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1" r:id="rId3"/>
    <p:sldId id="258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AFD8F3-33CA-4AC5-BCF1-201CA8E0BD8A}" v="1" dt="2025-02-03T12:33:51.4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4520" y="36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ng Pyo Kang" userId="736d9d377d64be0f" providerId="LiveId" clId="{2DAFD8F3-33CA-4AC5-BCF1-201CA8E0BD8A}"/>
    <pc:docChg chg="undo redo custSel delSld modSld">
      <pc:chgData name="Kyung Pyo Kang" userId="736d9d377d64be0f" providerId="LiveId" clId="{2DAFD8F3-33CA-4AC5-BCF1-201CA8E0BD8A}" dt="2025-02-03T12:50:57.541" v="51" actId="688"/>
      <pc:docMkLst>
        <pc:docMk/>
      </pc:docMkLst>
      <pc:sldChg chg="modSp mod">
        <pc:chgData name="Kyung Pyo Kang" userId="736d9d377d64be0f" providerId="LiveId" clId="{2DAFD8F3-33CA-4AC5-BCF1-201CA8E0BD8A}" dt="2025-02-03T12:50:02.611" v="24" actId="14100"/>
        <pc:sldMkLst>
          <pc:docMk/>
          <pc:sldMk cId="3065285193" sldId="256"/>
        </pc:sldMkLst>
        <pc:spChg chg="mod">
          <ac:chgData name="Kyung Pyo Kang" userId="736d9d377d64be0f" providerId="LiveId" clId="{2DAFD8F3-33CA-4AC5-BCF1-201CA8E0BD8A}" dt="2025-02-03T12:50:02.611" v="24" actId="14100"/>
          <ac:spMkLst>
            <pc:docMk/>
            <pc:sldMk cId="3065285193" sldId="256"/>
            <ac:spMk id="6" creationId="{3D4819DA-42BD-BEA2-5B8A-0B742FB5B842}"/>
          </ac:spMkLst>
        </pc:spChg>
      </pc:sldChg>
      <pc:sldChg chg="del">
        <pc:chgData name="Kyung Pyo Kang" userId="736d9d377d64be0f" providerId="LiveId" clId="{2DAFD8F3-33CA-4AC5-BCF1-201CA8E0BD8A}" dt="2025-02-03T12:33:21.834" v="0" actId="47"/>
        <pc:sldMkLst>
          <pc:docMk/>
          <pc:sldMk cId="1734490764" sldId="257"/>
        </pc:sldMkLst>
      </pc:sldChg>
      <pc:sldChg chg="addSp delSp modSp mod">
        <pc:chgData name="Kyung Pyo Kang" userId="736d9d377d64be0f" providerId="LiveId" clId="{2DAFD8F3-33CA-4AC5-BCF1-201CA8E0BD8A}" dt="2025-02-03T12:36:18.166" v="15" actId="732"/>
        <pc:sldMkLst>
          <pc:docMk/>
          <pc:sldMk cId="624800879" sldId="259"/>
        </pc:sldMkLst>
        <pc:picChg chg="del">
          <ac:chgData name="Kyung Pyo Kang" userId="736d9d377d64be0f" providerId="LiveId" clId="{2DAFD8F3-33CA-4AC5-BCF1-201CA8E0BD8A}" dt="2025-02-03T12:33:32.841" v="1" actId="478"/>
          <ac:picMkLst>
            <pc:docMk/>
            <pc:sldMk cId="624800879" sldId="259"/>
            <ac:picMk id="2" creationId="{C83ED6AA-E2CC-3CD4-57EE-884DF46690FA}"/>
          </ac:picMkLst>
        </pc:picChg>
        <pc:picChg chg="del">
          <ac:chgData name="Kyung Pyo Kang" userId="736d9d377d64be0f" providerId="LiveId" clId="{2DAFD8F3-33CA-4AC5-BCF1-201CA8E0BD8A}" dt="2025-02-03T12:33:33.558" v="2" actId="478"/>
          <ac:picMkLst>
            <pc:docMk/>
            <pc:sldMk cId="624800879" sldId="259"/>
            <ac:picMk id="3" creationId="{6C164A57-56DC-1D56-5C29-BD0A55A2B4E4}"/>
          </ac:picMkLst>
        </pc:picChg>
        <pc:picChg chg="add mod ord modCrop">
          <ac:chgData name="Kyung Pyo Kang" userId="736d9d377d64be0f" providerId="LiveId" clId="{2DAFD8F3-33CA-4AC5-BCF1-201CA8E0BD8A}" dt="2025-02-03T12:36:18.166" v="15" actId="732"/>
          <ac:picMkLst>
            <pc:docMk/>
            <pc:sldMk cId="624800879" sldId="259"/>
            <ac:picMk id="11" creationId="{2E302DA4-BE12-3F1F-1786-0B23CBA91E17}"/>
          </ac:picMkLst>
        </pc:picChg>
        <pc:picChg chg="add mod ord">
          <ac:chgData name="Kyung Pyo Kang" userId="736d9d377d64be0f" providerId="LiveId" clId="{2DAFD8F3-33CA-4AC5-BCF1-201CA8E0BD8A}" dt="2025-02-03T12:34:11.459" v="7" actId="1076"/>
          <ac:picMkLst>
            <pc:docMk/>
            <pc:sldMk cId="624800879" sldId="259"/>
            <ac:picMk id="12" creationId="{94A95A08-B470-49FF-658D-1E89C8DBBBE6}"/>
          </ac:picMkLst>
        </pc:picChg>
      </pc:sldChg>
      <pc:sldChg chg="modSp mod">
        <pc:chgData name="Kyung Pyo Kang" userId="736d9d377d64be0f" providerId="LiveId" clId="{2DAFD8F3-33CA-4AC5-BCF1-201CA8E0BD8A}" dt="2025-02-03T12:50:57.541" v="51" actId="688"/>
        <pc:sldMkLst>
          <pc:docMk/>
          <pc:sldMk cId="3267601749" sldId="261"/>
        </pc:sldMkLst>
        <pc:picChg chg="mod">
          <ac:chgData name="Kyung Pyo Kang" userId="736d9d377d64be0f" providerId="LiveId" clId="{2DAFD8F3-33CA-4AC5-BCF1-201CA8E0BD8A}" dt="2025-02-03T12:50:16.213" v="25" actId="1582"/>
          <ac:picMkLst>
            <pc:docMk/>
            <pc:sldMk cId="3267601749" sldId="261"/>
            <ac:picMk id="6" creationId="{412E9582-E441-5AD0-F531-A8CA89EF9ED3}"/>
          </ac:picMkLst>
        </pc:picChg>
        <pc:picChg chg="mod">
          <ac:chgData name="Kyung Pyo Kang" userId="736d9d377d64be0f" providerId="LiveId" clId="{2DAFD8F3-33CA-4AC5-BCF1-201CA8E0BD8A}" dt="2025-02-03T12:50:57.541" v="51" actId="688"/>
          <ac:picMkLst>
            <pc:docMk/>
            <pc:sldMk cId="3267601749" sldId="261"/>
            <ac:picMk id="8" creationId="{6FD3F1F3-B3CC-5F32-5B2C-06A28367E81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7430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5032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3334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097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9080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34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5634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8181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453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8233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5771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D93AD8-7E34-4BBE-BDEE-4C7FD49D4660}" type="datetimeFigureOut">
              <a:rPr lang="ko-KR" altLang="en-US" smtClean="0"/>
              <a:t>2025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D7E86A-8A4E-421F-9558-846A8332E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4993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 descr="图片包含 器具, 冰箱, 游戏机, 桌子&#10;&#10;描述已自动生成">
            <a:extLst>
              <a:ext uri="{FF2B5EF4-FFF2-40B4-BE49-F238E27FC236}">
                <a16:creationId xmlns:a16="http://schemas.microsoft.com/office/drawing/2014/main" id="{2A6A32BF-3609-A4EF-F6F7-E79DCCE713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7474" y="1455078"/>
            <a:ext cx="2981992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图片 4" descr="打开门的冰箱&#10;&#10;低可信度描述已自动生成">
            <a:extLst>
              <a:ext uri="{FF2B5EF4-FFF2-40B4-BE49-F238E27FC236}">
                <a16:creationId xmlns:a16="http://schemas.microsoft.com/office/drawing/2014/main" id="{944D59EE-D221-9DCC-22F7-9530C7C938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53" y="1455078"/>
            <a:ext cx="2981992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3D4819DA-42BD-BEA2-5B8A-0B742FB5B842}"/>
              </a:ext>
            </a:extLst>
          </p:cNvPr>
          <p:cNvSpPr/>
          <p:nvPr/>
        </p:nvSpPr>
        <p:spPr>
          <a:xfrm>
            <a:off x="537029" y="2968172"/>
            <a:ext cx="2271485" cy="27577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C4063EF8-68FB-D856-5029-E4472B4027B8}"/>
              </a:ext>
            </a:extLst>
          </p:cNvPr>
          <p:cNvSpPr/>
          <p:nvPr/>
        </p:nvSpPr>
        <p:spPr>
          <a:xfrm>
            <a:off x="3823855" y="3442855"/>
            <a:ext cx="2407227" cy="40524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D35250-942F-9506-16FF-03B2CDE33340}"/>
              </a:ext>
            </a:extLst>
          </p:cNvPr>
          <p:cNvSpPr txBox="1"/>
          <p:nvPr/>
        </p:nvSpPr>
        <p:spPr>
          <a:xfrm>
            <a:off x="1067851" y="105987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VEGFR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19722C-18D1-D1C3-CBE1-85005F3C8114}"/>
              </a:ext>
            </a:extLst>
          </p:cNvPr>
          <p:cNvSpPr txBox="1"/>
          <p:nvPr/>
        </p:nvSpPr>
        <p:spPr>
          <a:xfrm>
            <a:off x="4560653" y="105987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B21EBC-44A7-FBA0-D8EB-85694614BEC9}"/>
              </a:ext>
            </a:extLst>
          </p:cNvPr>
          <p:cNvSpPr txBox="1"/>
          <p:nvPr/>
        </p:nvSpPr>
        <p:spPr>
          <a:xfrm>
            <a:off x="0" y="0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ko-KR" sz="14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3">
            <a:extLst>
              <a:ext uri="{FF2B5EF4-FFF2-40B4-BE49-F238E27FC236}">
                <a16:creationId xmlns:a16="http://schemas.microsoft.com/office/drawing/2014/main" id="{1AC14E3C-E60C-E4D8-B7CC-C4223F317A70}"/>
              </a:ext>
            </a:extLst>
          </p:cNvPr>
          <p:cNvSpPr txBox="1"/>
          <p:nvPr/>
        </p:nvSpPr>
        <p:spPr>
          <a:xfrm>
            <a:off x="21347" y="5614152"/>
            <a:ext cx="323494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oat 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nti-VEGFR-3 (AF74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3; dilution 1:1000; R&amp;D Systems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endParaRPr lang="en-US" altLang="zh-CN" sz="1200" b="1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8">
            <a:extLst>
              <a:ext uri="{FF2B5EF4-FFF2-40B4-BE49-F238E27FC236}">
                <a16:creationId xmlns:a16="http://schemas.microsoft.com/office/drawing/2014/main" id="{48CEEBA1-FC18-7103-186D-51B1D3DB6788}"/>
              </a:ext>
            </a:extLst>
          </p:cNvPr>
          <p:cNvSpPr txBox="1"/>
          <p:nvPr/>
        </p:nvSpPr>
        <p:spPr>
          <a:xfrm>
            <a:off x="3527474" y="5635354"/>
            <a:ext cx="31872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Rabbit anti-HSP90 polyclonal antibody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</a:rPr>
              <a:t> (ADI-SPA-836, dilution 1:1000; Enzo </a:t>
            </a:r>
            <a:r>
              <a:rPr lang="en-US" altLang="zh-CN" sz="1200" b="1" i="0" u="none" strike="noStrike" baseline="0" dirty="0" err="1">
                <a:latin typeface="Arial" panose="020B0604020202020204" pitchFamily="34" charset="0"/>
              </a:rPr>
              <a:t>Biochem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</a:rPr>
              <a:t> Inc)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65285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4C3676-DA76-04EF-6B56-B3B8C39D1F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70" descr="图片包含 室内, 厨房, 冰箱, 看着&#10;&#10;描述已自动生成">
            <a:extLst>
              <a:ext uri="{FF2B5EF4-FFF2-40B4-BE49-F238E27FC236}">
                <a16:creationId xmlns:a16="http://schemas.microsoft.com/office/drawing/2014/main" id="{412E9582-E441-5AD0-F531-A8CA89EF9E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879" y="2441756"/>
            <a:ext cx="2955600" cy="40639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图片 74" descr="文本&#10;&#10;描述已自动生成">
            <a:extLst>
              <a:ext uri="{FF2B5EF4-FFF2-40B4-BE49-F238E27FC236}">
                <a16:creationId xmlns:a16="http://schemas.microsoft.com/office/drawing/2014/main" id="{6FD3F1F3-B3CC-5F32-5B2C-06A28367E8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6077" y="2425007"/>
            <a:ext cx="2955600" cy="40639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5B815072-A776-8508-1C3E-B2F6125E65AE}"/>
              </a:ext>
            </a:extLst>
          </p:cNvPr>
          <p:cNvSpPr/>
          <p:nvPr/>
        </p:nvSpPr>
        <p:spPr>
          <a:xfrm>
            <a:off x="729342" y="4382200"/>
            <a:ext cx="2484000" cy="252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97284A52-B339-E4A9-33B9-31B0F1FB24C8}"/>
              </a:ext>
            </a:extLst>
          </p:cNvPr>
          <p:cNvSpPr/>
          <p:nvPr/>
        </p:nvSpPr>
        <p:spPr>
          <a:xfrm>
            <a:off x="3821571" y="3004457"/>
            <a:ext cx="2503030" cy="381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9631CF1-03ED-A692-452C-C0990310E356}"/>
              </a:ext>
            </a:extLst>
          </p:cNvPr>
          <p:cNvSpPr txBox="1"/>
          <p:nvPr/>
        </p:nvSpPr>
        <p:spPr>
          <a:xfrm>
            <a:off x="1270605" y="1911548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VEGF-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A329177-0D33-45D6-DDC5-38E6B5045A62}"/>
              </a:ext>
            </a:extLst>
          </p:cNvPr>
          <p:cNvSpPr txBox="1"/>
          <p:nvPr/>
        </p:nvSpPr>
        <p:spPr>
          <a:xfrm>
            <a:off x="4602392" y="1911548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9C738B-27CD-78C7-374E-9DF4D84645A9}"/>
              </a:ext>
            </a:extLst>
          </p:cNvPr>
          <p:cNvSpPr txBox="1"/>
          <p:nvPr/>
        </p:nvSpPr>
        <p:spPr>
          <a:xfrm>
            <a:off x="0" y="0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altLang="ko-KR" sz="14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55C72C-B9C1-224E-41D2-2D314B21787C}"/>
              </a:ext>
            </a:extLst>
          </p:cNvPr>
          <p:cNvSpPr txBox="1"/>
          <p:nvPr/>
        </p:nvSpPr>
        <p:spPr>
          <a:xfrm>
            <a:off x="315879" y="6598949"/>
            <a:ext cx="298199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abbit anti-VEGF-C (ab9546; dilution 1:1,000; Abca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D12FAE-9F12-5365-4172-3D934490F7DB}"/>
              </a:ext>
            </a:extLst>
          </p:cNvPr>
          <p:cNvSpPr txBox="1"/>
          <p:nvPr/>
        </p:nvSpPr>
        <p:spPr>
          <a:xfrm>
            <a:off x="3486077" y="6576429"/>
            <a:ext cx="303445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Actin (C4) (sc-47778; dilution, 1:2,000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anta Cruz Biotechnology Inc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7601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4" descr="图片包含 室内, 冰箱, 游戏机, 炉子&#10;&#10;描述已自动生成">
            <a:extLst>
              <a:ext uri="{FF2B5EF4-FFF2-40B4-BE49-F238E27FC236}">
                <a16:creationId xmlns:a16="http://schemas.microsoft.com/office/drawing/2014/main" id="{F3535EA1-16F6-B780-FB0D-546AB39C8E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95" y="2414450"/>
            <a:ext cx="2981992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图片 9" descr="在门上&#10;&#10;低可信度描述已自动生成">
            <a:extLst>
              <a:ext uri="{FF2B5EF4-FFF2-40B4-BE49-F238E27FC236}">
                <a16:creationId xmlns:a16="http://schemas.microsoft.com/office/drawing/2014/main" id="{18089504-37F0-AE45-8370-D69CC5F031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8845" y="2414450"/>
            <a:ext cx="2981992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B076C66-B8AE-FD2B-6E73-578E1565D771}"/>
              </a:ext>
            </a:extLst>
          </p:cNvPr>
          <p:cNvSpPr txBox="1"/>
          <p:nvPr/>
        </p:nvSpPr>
        <p:spPr>
          <a:xfrm>
            <a:off x="1177646" y="2028869"/>
            <a:ext cx="802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LR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9F3576-8236-4515-CE00-37BB300A6055}"/>
              </a:ext>
            </a:extLst>
          </p:cNvPr>
          <p:cNvSpPr txBox="1"/>
          <p:nvPr/>
        </p:nvSpPr>
        <p:spPr>
          <a:xfrm>
            <a:off x="4602024" y="202775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3">
            <a:extLst>
              <a:ext uri="{FF2B5EF4-FFF2-40B4-BE49-F238E27FC236}">
                <a16:creationId xmlns:a16="http://schemas.microsoft.com/office/drawing/2014/main" id="{877B7D41-1F84-9B83-FDFF-74B4DA5B682A}"/>
              </a:ext>
            </a:extLst>
          </p:cNvPr>
          <p:cNvSpPr txBox="1"/>
          <p:nvPr/>
        </p:nvSpPr>
        <p:spPr>
          <a:xfrm>
            <a:off x="21987" y="6637219"/>
            <a:ext cx="304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abbit anti-Toll-like Receptor 7 (E4J3Z) </a:t>
            </a:r>
          </a:p>
          <a:p>
            <a:pPr algn="l"/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(#82658, Dilution 1:1000; Cell signaling technology, MW 140, 120, 74)</a:t>
            </a:r>
          </a:p>
        </p:txBody>
      </p:sp>
      <p:sp>
        <p:nvSpPr>
          <p:cNvPr id="7" name="文本框 8">
            <a:extLst>
              <a:ext uri="{FF2B5EF4-FFF2-40B4-BE49-F238E27FC236}">
                <a16:creationId xmlns:a16="http://schemas.microsoft.com/office/drawing/2014/main" id="{AB07EF1E-4615-C83D-984E-7F63DA1AFEDF}"/>
              </a:ext>
            </a:extLst>
          </p:cNvPr>
          <p:cNvSpPr txBox="1"/>
          <p:nvPr/>
        </p:nvSpPr>
        <p:spPr>
          <a:xfrm>
            <a:off x="3518428" y="6637218"/>
            <a:ext cx="31872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Rabbit anti-HSP90 polyclonal antibody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</a:rPr>
              <a:t> (ADI-SPA-836, dilution 1:1000; Enzo </a:t>
            </a:r>
            <a:r>
              <a:rPr lang="en-US" altLang="zh-CN" sz="1200" b="1" i="0" u="none" strike="noStrike" baseline="0" dirty="0" err="1">
                <a:latin typeface="Arial" panose="020B0604020202020204" pitchFamily="34" charset="0"/>
              </a:rPr>
              <a:t>Biochem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</a:rPr>
              <a:t> Inc)</a:t>
            </a:r>
            <a:endParaRPr lang="zh-CN" altLang="en-US" sz="1200" b="1" dirty="0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F234886B-4BEE-A288-DB46-D3A823C359E9}"/>
              </a:ext>
            </a:extLst>
          </p:cNvPr>
          <p:cNvSpPr/>
          <p:nvPr/>
        </p:nvSpPr>
        <p:spPr>
          <a:xfrm>
            <a:off x="532993" y="3592629"/>
            <a:ext cx="2403356" cy="35836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9C425B18-6AD0-5F6D-3745-B621A78BFB36}"/>
              </a:ext>
            </a:extLst>
          </p:cNvPr>
          <p:cNvSpPr/>
          <p:nvPr/>
        </p:nvSpPr>
        <p:spPr>
          <a:xfrm>
            <a:off x="3968260" y="4384639"/>
            <a:ext cx="2403356" cy="2546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3AC4D8-F863-F550-B479-D9EA09E938A2}"/>
              </a:ext>
            </a:extLst>
          </p:cNvPr>
          <p:cNvSpPr txBox="1"/>
          <p:nvPr/>
        </p:nvSpPr>
        <p:spPr>
          <a:xfrm>
            <a:off x="0" y="0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altLang="ko-KR" sz="14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28105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8" descr="图片包含 室内, 厨房, 小, 水&#10;&#10;描述已自动生成">
            <a:extLst>
              <a:ext uri="{FF2B5EF4-FFF2-40B4-BE49-F238E27FC236}">
                <a16:creationId xmlns:a16="http://schemas.microsoft.com/office/drawing/2014/main" id="{2E302DA4-BE12-3F1F-1786-0B23CBA91E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061" y="2430779"/>
            <a:ext cx="2981992" cy="4100239"/>
          </a:xfrm>
          <a:prstGeom prst="rect">
            <a:avLst/>
          </a:prstGeom>
        </p:spPr>
      </p:pic>
      <p:pic>
        <p:nvPicPr>
          <p:cNvPr id="12" name="图片 9" descr="图片包含 室内, 门, 盒子, 冰箱&#10;&#10;描述已自动生成">
            <a:extLst>
              <a:ext uri="{FF2B5EF4-FFF2-40B4-BE49-F238E27FC236}">
                <a16:creationId xmlns:a16="http://schemas.microsoft.com/office/drawing/2014/main" id="{94A95A08-B470-49FF-658D-1E89C8DBBB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6506" y="2430779"/>
            <a:ext cx="2981992" cy="4100239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61C2A28F-9B62-68EB-2031-A74B7500092C}"/>
              </a:ext>
            </a:extLst>
          </p:cNvPr>
          <p:cNvSpPr/>
          <p:nvPr/>
        </p:nvSpPr>
        <p:spPr>
          <a:xfrm>
            <a:off x="726936" y="3909760"/>
            <a:ext cx="2403356" cy="2546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40B66BC7-4B1F-5B72-ED98-2536BAC4B361}"/>
              </a:ext>
            </a:extLst>
          </p:cNvPr>
          <p:cNvSpPr/>
          <p:nvPr/>
        </p:nvSpPr>
        <p:spPr>
          <a:xfrm>
            <a:off x="4061007" y="3737938"/>
            <a:ext cx="2403356" cy="2546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文本框 24">
            <a:extLst>
              <a:ext uri="{FF2B5EF4-FFF2-40B4-BE49-F238E27FC236}">
                <a16:creationId xmlns:a16="http://schemas.microsoft.com/office/drawing/2014/main" id="{3A8DABCE-AFFD-B360-390B-BF6AAEA309D1}"/>
              </a:ext>
            </a:extLst>
          </p:cNvPr>
          <p:cNvSpPr txBox="1"/>
          <p:nvPr/>
        </p:nvSpPr>
        <p:spPr>
          <a:xfrm>
            <a:off x="135664" y="6713356"/>
            <a:ext cx="316201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Rabbit anti-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yD88 (D80F5)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4283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; dilution,  1:1,000;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ell signaling technology, MW 33 </a:t>
            </a:r>
            <a:r>
              <a:rPr lang="en-US" altLang="zh-CN" sz="12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B27021E-F550-36EF-7E84-368AF5134F73}"/>
              </a:ext>
            </a:extLst>
          </p:cNvPr>
          <p:cNvSpPr txBox="1"/>
          <p:nvPr/>
        </p:nvSpPr>
        <p:spPr>
          <a:xfrm>
            <a:off x="3560322" y="6713356"/>
            <a:ext cx="298199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Actin (C4) (sc-47778; dilution, 1:2,000, Santa Cruz Biotechnology Inc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23DF28-4B9F-9FE4-EA2F-C1BCAEB02893}"/>
              </a:ext>
            </a:extLst>
          </p:cNvPr>
          <p:cNvSpPr txBox="1"/>
          <p:nvPr/>
        </p:nvSpPr>
        <p:spPr>
          <a:xfrm>
            <a:off x="1151623" y="2062560"/>
            <a:ext cx="1029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yD8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1E804A5-BE88-1248-76E4-94B4E80DA6C7}"/>
              </a:ext>
            </a:extLst>
          </p:cNvPr>
          <p:cNvSpPr txBox="1"/>
          <p:nvPr/>
        </p:nvSpPr>
        <p:spPr>
          <a:xfrm>
            <a:off x="4561441" y="206144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FA0A893-6F9C-4A60-E52D-ADC5FA6C7E78}"/>
              </a:ext>
            </a:extLst>
          </p:cNvPr>
          <p:cNvSpPr txBox="1"/>
          <p:nvPr/>
        </p:nvSpPr>
        <p:spPr>
          <a:xfrm>
            <a:off x="0" y="0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altLang="ko-KR" sz="14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48008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9" descr="图片包含 室内, 厨房, 冰箱, 窗户&#10;&#10;描述已自动生成">
            <a:extLst>
              <a:ext uri="{FF2B5EF4-FFF2-40B4-BE49-F238E27FC236}">
                <a16:creationId xmlns:a16="http://schemas.microsoft.com/office/drawing/2014/main" id="{6EE28382-D43A-FA88-BBCE-7D210C57E4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185" y="2568285"/>
            <a:ext cx="2981993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图片 4" descr="手机屏幕的截图&#10;&#10;中度可信度描述已自动生成">
            <a:extLst>
              <a:ext uri="{FF2B5EF4-FFF2-40B4-BE49-F238E27FC236}">
                <a16:creationId xmlns:a16="http://schemas.microsoft.com/office/drawing/2014/main" id="{51689E52-BC74-B22A-CFF0-72C78182B7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0786" y="2568285"/>
            <a:ext cx="2981992" cy="41002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文本框 2">
            <a:extLst>
              <a:ext uri="{FF2B5EF4-FFF2-40B4-BE49-F238E27FC236}">
                <a16:creationId xmlns:a16="http://schemas.microsoft.com/office/drawing/2014/main" id="{CC7C5C5A-E8C7-950E-B30E-3E2747DD6E5A}"/>
              </a:ext>
            </a:extLst>
          </p:cNvPr>
          <p:cNvSpPr txBox="1"/>
          <p:nvPr/>
        </p:nvSpPr>
        <p:spPr>
          <a:xfrm>
            <a:off x="211185" y="6697878"/>
            <a:ext cx="29370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abbit anti-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FN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-α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b="1" kern="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#PA5-115430, dilution 1:1,000, </a:t>
            </a:r>
            <a:r>
              <a:rPr lang="en-US" altLang="ko-KR" sz="1200" b="1" dirty="0" err="1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hermo</a:t>
            </a:r>
            <a:r>
              <a:rPr lang="en-US" altLang="ko-KR" sz="12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Fisher Scientific)</a:t>
            </a:r>
            <a:endParaRPr lang="en-US" altLang="zh-CN" sz="1200" b="1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BF7D61-A8B9-FC4E-3CE7-1AF39398A206}"/>
              </a:ext>
            </a:extLst>
          </p:cNvPr>
          <p:cNvSpPr txBox="1"/>
          <p:nvPr/>
        </p:nvSpPr>
        <p:spPr>
          <a:xfrm>
            <a:off x="1187614" y="2178732"/>
            <a:ext cx="1029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F10156-AA2F-A106-22FA-9312C4645657}"/>
              </a:ext>
            </a:extLst>
          </p:cNvPr>
          <p:cNvSpPr txBox="1"/>
          <p:nvPr/>
        </p:nvSpPr>
        <p:spPr>
          <a:xfrm>
            <a:off x="4605324" y="217873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792001F-8130-8E1D-8443-46C3960E752E}"/>
              </a:ext>
            </a:extLst>
          </p:cNvPr>
          <p:cNvSpPr txBox="1"/>
          <p:nvPr/>
        </p:nvSpPr>
        <p:spPr>
          <a:xfrm>
            <a:off x="3670786" y="6790212"/>
            <a:ext cx="308465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Actin (C4) (sc-47778; dilution, 1:2,000, Santa Cruz Biotechnology Inc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5B0BAD55-9889-CD01-0F12-799EF5262D50}"/>
              </a:ext>
            </a:extLst>
          </p:cNvPr>
          <p:cNvSpPr/>
          <p:nvPr/>
        </p:nvSpPr>
        <p:spPr>
          <a:xfrm>
            <a:off x="636287" y="4491062"/>
            <a:ext cx="2403356" cy="2546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A75E22AE-57A8-210A-7885-CEAE2E8A89AD}"/>
              </a:ext>
            </a:extLst>
          </p:cNvPr>
          <p:cNvSpPr/>
          <p:nvPr/>
        </p:nvSpPr>
        <p:spPr>
          <a:xfrm>
            <a:off x="3966979" y="4169074"/>
            <a:ext cx="2403356" cy="2546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90C6F4-D693-0811-86BA-BF6DECD166ED}"/>
              </a:ext>
            </a:extLst>
          </p:cNvPr>
          <p:cNvSpPr txBox="1"/>
          <p:nvPr/>
        </p:nvSpPr>
        <p:spPr>
          <a:xfrm>
            <a:off x="0" y="0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altLang="ko-KR" sz="14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4666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</TotalTime>
  <Words>196</Words>
  <Application>Microsoft Office PowerPoint</Application>
  <PresentationFormat>A4 용지(210x297mm)</PresentationFormat>
  <Paragraphs>26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yung Pyo Kang</dc:creator>
  <cp:lastModifiedBy>Kyung Pyo Kang</cp:lastModifiedBy>
  <cp:revision>3</cp:revision>
  <dcterms:created xsi:type="dcterms:W3CDTF">2024-10-03T11:43:35Z</dcterms:created>
  <dcterms:modified xsi:type="dcterms:W3CDTF">2025-02-03T12:51:02Z</dcterms:modified>
</cp:coreProperties>
</file>